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4" autoAdjust="0"/>
    <p:restoredTop sz="94660"/>
  </p:normalViewPr>
  <p:slideViewPr>
    <p:cSldViewPr snapToGrid="0">
      <p:cViewPr varScale="1">
        <p:scale>
          <a:sx n="99" d="100"/>
          <a:sy n="99" d="100"/>
        </p:scale>
        <p:origin x="111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Revised%20GNB4%20for%20BMC%20resubmision\GNB4%20densitometry_Suppl%20Fig%20S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182</a:t>
            </a:r>
            <a:r>
              <a:rPr lang="en-US" sz="1200" baseline="30000">
                <a:solidFill>
                  <a:sysClr val="windowText" lastClr="000000"/>
                </a:solidFill>
              </a:rPr>
              <a:t>R</a:t>
            </a:r>
            <a:r>
              <a:rPr lang="en-US" sz="1200">
                <a:solidFill>
                  <a:sysClr val="windowText" lastClr="000000"/>
                </a:solidFill>
              </a:rPr>
              <a:t>-6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1:$C$1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6.8320426301545162E-3</c:v>
                  </c:pt>
                </c:numCache>
              </c:numRef>
            </c:plus>
            <c:minus>
              <c:numRef>
                <c:f>Sheet1!$C$11:$C$1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6.832042630154516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1:$A$12</c:f>
              <c:strCache>
                <c:ptCount val="2"/>
                <c:pt idx="0">
                  <c:v>Negative control siRNA</c:v>
                </c:pt>
                <c:pt idx="1">
                  <c:v>GNB4 siRNA</c:v>
                </c:pt>
              </c:strCache>
            </c:strRef>
          </c:cat>
          <c:val>
            <c:numRef>
              <c:f>Sheet1!$B$11:$B$12</c:f>
              <c:numCache>
                <c:formatCode>General</c:formatCode>
                <c:ptCount val="2"/>
                <c:pt idx="0">
                  <c:v>1</c:v>
                </c:pt>
                <c:pt idx="1">
                  <c:v>0.743576882935828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312528"/>
        <c:axId val="146312920"/>
      </c:barChart>
      <c:catAx>
        <c:axId val="146312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146312920"/>
        <c:crosses val="autoZero"/>
        <c:auto val="1"/>
        <c:lblAlgn val="ctr"/>
        <c:lblOffset val="100"/>
        <c:noMultiLvlLbl val="0"/>
      </c:catAx>
      <c:valAx>
        <c:axId val="146312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GNB4/Actin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312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764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519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154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708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58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407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21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821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568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933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749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19500-6407-4F31-9395-CEC0E577C9E1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78056-BAF1-4951-B2E7-DE06A49B7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610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7622" t="29779" r="11586" b="31455"/>
          <a:stretch/>
        </p:blipFill>
        <p:spPr>
          <a:xfrm>
            <a:off x="1709158" y="3051299"/>
            <a:ext cx="1645920" cy="43338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3957" t="18677" r="4677" b="18128"/>
          <a:stretch/>
        </p:blipFill>
        <p:spPr>
          <a:xfrm>
            <a:off x="1709158" y="3589468"/>
            <a:ext cx="1645920" cy="44766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77366" y="4410855"/>
            <a:ext cx="1563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M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1         18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/>
          <p:cNvCxnSpPr/>
          <p:nvPr/>
        </p:nvCxnSpPr>
        <p:spPr>
          <a:xfrm>
            <a:off x="1718684" y="4100896"/>
            <a:ext cx="5029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2271136" y="4100891"/>
            <a:ext cx="5029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2818826" y="4100880"/>
            <a:ext cx="5029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718673" y="4397093"/>
            <a:ext cx="10515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2818815" y="4397077"/>
            <a:ext cx="5029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782105" y="4114679"/>
            <a:ext cx="318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          96        96 (hours post-transfection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354151" y="3122732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NB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58906" y="364661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52144" y="632460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4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 rot="16200000">
            <a:off x="1759509" y="1450308"/>
            <a:ext cx="1489510" cy="17193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>
                <a:latin typeface="Arial Narrow" panose="020B0606020202030204" pitchFamily="34" charset="0"/>
              </a:rPr>
              <a:t>Negative control siRNA</a:t>
            </a:r>
          </a:p>
          <a:p>
            <a:pPr>
              <a:lnSpc>
                <a:spcPct val="150000"/>
              </a:lnSpc>
            </a:pPr>
            <a:r>
              <a:rPr lang="en-US" sz="1200" dirty="0" smtClean="0">
                <a:latin typeface="Arial Narrow" panose="020B0606020202030204" pitchFamily="34" charset="0"/>
              </a:rPr>
              <a:t>GNB4 siRNA</a:t>
            </a: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 Narrow" panose="020B0606020202030204" pitchFamily="34" charset="0"/>
              </a:rPr>
              <a:t>Negative control siRNA</a:t>
            </a: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 Narrow" panose="020B0606020202030204" pitchFamily="34" charset="0"/>
              </a:rPr>
              <a:t>GNB4 siRNA</a:t>
            </a: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 Narrow" panose="020B0606020202030204" pitchFamily="34" charset="0"/>
              </a:rPr>
              <a:t>Negative control siRNA</a:t>
            </a: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 Narrow" panose="020B0606020202030204" pitchFamily="34" charset="0"/>
              </a:rPr>
              <a:t>GNB4 </a:t>
            </a:r>
            <a:r>
              <a:rPr lang="en-US" sz="1200" dirty="0" smtClean="0">
                <a:latin typeface="Arial Narrow" panose="020B0606020202030204" pitchFamily="34" charset="0"/>
              </a:rPr>
              <a:t>siRNA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graphicFrame>
        <p:nvGraphicFramePr>
          <p:cNvPr id="18" name="Chart 17"/>
          <p:cNvGraphicFramePr>
            <a:graphicFrameLocks/>
          </p:cNvGraphicFramePr>
          <p:nvPr>
            <p:extLst/>
          </p:nvPr>
        </p:nvGraphicFramePr>
        <p:xfrm>
          <a:off x="5243320" y="1751132"/>
          <a:ext cx="272891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198338" y="259044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64268" y="14569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116393" y="17375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43384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Leth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Bo</dc:creator>
  <cp:lastModifiedBy>Kovalchuk, Olga</cp:lastModifiedBy>
  <cp:revision>2</cp:revision>
  <dcterms:created xsi:type="dcterms:W3CDTF">2018-05-29T17:29:55Z</dcterms:created>
  <dcterms:modified xsi:type="dcterms:W3CDTF">2018-06-01T18:42:13Z</dcterms:modified>
</cp:coreProperties>
</file>